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18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114" y="600"/>
      </p:cViewPr>
      <p:guideLst>
        <p:guide orient="horz" pos="2818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6D2F5DA-0FC7-4875-9123-DD93D5DEA5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493A3F5C-3BCB-4812-B81A-B39E0AA43F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388F3A2-88B0-41A2-89A4-45AD28E7CF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061-8ABD-4530-BD26-5381F0AD2F59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AEC7958-F370-4224-A852-EE916E45D7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7DDBD11-00E1-46DA-B814-F047D76234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56654-761A-473C-A66E-6A3F72E623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7616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5572FCB-DC96-4AE6-BD8C-68FFB158F4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D0157D0-5F88-4596-A0FB-D1BE1D9195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F5B0A73-3400-4BB9-87BF-66D8214F5F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061-8ABD-4530-BD26-5381F0AD2F59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DCEAB87-136B-4B2F-8EAD-E34A7BDE19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9CE5412-F85D-4C3B-9094-E3BEFA8D49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56654-761A-473C-A66E-6A3F72E623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90608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E9F63817-800D-444E-A159-7177980DA1C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286F0E77-F136-4AD1-B297-E39B2A9B6F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3B06ECF-FFAB-4EC8-8F03-1D5D8DB67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061-8ABD-4530-BD26-5381F0AD2F59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B8F1DD5-9F85-4290-B0C2-D5CD88BDF9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CB1F08C-0F36-4D23-A53A-52A7599871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56654-761A-473C-A66E-6A3F72E623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1049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47879CB-62AE-4490-B133-0749EA5413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A0CDE4A-5B7B-41E5-AF0C-650DB36A88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0A4AB14-FDC2-41D1-B351-A765FC1CEA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061-8ABD-4530-BD26-5381F0AD2F59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FA6524E-643A-4D84-A70B-6DEBE9BB88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28672ED-7BDB-40E3-9A7F-AFFE04921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56654-761A-473C-A66E-6A3F72E623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61035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14C99B7-30FB-4323-8F82-BE00B0969C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E2FFC56-4980-40B1-9C49-C0F245FEC5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DBE6ACE-F553-4957-B074-A03B00FEC5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061-8ABD-4530-BD26-5381F0AD2F59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2A23DBF-BBA0-403F-A8DF-12E233D496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6A1EE61-039A-4165-B2AE-39B1E818EE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56654-761A-473C-A66E-6A3F72E623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5666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69DC4CE-9153-401B-AF0A-A5624F07C2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A2016F20-C921-411D-B02C-879F551BA45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2330014-C87B-4FCA-A8C7-7D628048F7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CA3D80D-7CFD-4BCF-8F7B-4E9709FE33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061-8ABD-4530-BD26-5381F0AD2F59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CE47F7A-1AB9-41A1-8A9B-1A23AA4926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CDD90C83-725C-465A-B594-D67AAD40BD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56654-761A-473C-A66E-6A3F72E623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19366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BB98FF9-2148-46CD-AAD0-5134EC016D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97503C3-9DA4-428B-845F-700721228E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85A62DE-436F-402E-99FA-B55E5C348F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44C75DA0-7895-4DA9-9AD4-735E9E3535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7ADB06D6-FCFA-4B1F-B6B3-8AACEAEC90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8A8EE835-3859-4235-9A65-DA7C5CF476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061-8ABD-4530-BD26-5381F0AD2F59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215C973F-C91E-4B68-BDE6-48A6A1B950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0F9C38C7-CC89-497B-BF39-41B980B0C8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56654-761A-473C-A66E-6A3F72E623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2604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9F851A6-FCC6-4AC3-A666-5BD3CF61BC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F16CEB2D-6C7A-470E-8113-9F6F96BC0A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061-8ABD-4530-BD26-5381F0AD2F59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286D7086-5C49-4118-A9D1-125D8C547E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A7176AAD-BCC7-4EE0-9FA3-23562C8AED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56654-761A-473C-A66E-6A3F72E623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69124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6981902E-1D0D-427C-8769-B32C763BCF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061-8ABD-4530-BD26-5381F0AD2F59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5A4B1A9A-B2FB-4735-9035-BF2A417A08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491DD04B-3EAB-4C87-B937-2CC7036D7C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56654-761A-473C-A66E-6A3F72E623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54376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5BB9A41-3E3A-447B-B848-50B35B3773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17B6E52-D9B8-4960-828A-EE0A263BA6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F5AF27D2-5CB8-4B18-A5BF-D2342AB7BD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4FD1C62-C9D3-4056-897E-978A61E0DF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061-8ABD-4530-BD26-5381F0AD2F59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2B135A4-2AD2-4CC0-8861-0B86841A07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EE4529D-7302-4F6E-97B2-747BC08863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56654-761A-473C-A66E-6A3F72E623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63563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53E8DF8-ED90-48E4-9AE2-6F985051DB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C9F9AA9D-20E6-4C67-A0CA-9CAB678EBD3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CB6F69EC-20BC-403E-B03A-FA74CE70BB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7B6E7399-711F-4BDB-A4AA-5822D0C082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061-8ABD-4530-BD26-5381F0AD2F59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BE5CC28-AA35-455A-ABF6-997F815A84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C8648442-B419-4CC9-9B59-7820E7833A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56654-761A-473C-A66E-6A3F72E623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11076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51EF1280-7548-4920-A86C-2BB96D9771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CFAB872-0320-451A-9AA8-4211DD26F5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FCB55D9-FD66-482F-BEFB-35C6D8E443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6CC061-8ABD-4530-BD26-5381F0AD2F59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784E516-44B0-4542-BCC0-EF111421C54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35C7FB1-C4F5-4169-B340-4E956FD8FFA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C56654-761A-473C-A66E-6A3F72E623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7060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w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525638" y="213059"/>
            <a:ext cx="11618119" cy="6248483"/>
            <a:chOff x="525638" y="213059"/>
            <a:chExt cx="11618119" cy="6248483"/>
          </a:xfrm>
        </p:grpSpPr>
        <p:pic>
          <p:nvPicPr>
            <p:cNvPr id="7" name="Grafik 6">
              <a:extLst>
                <a:ext uri="{FF2B5EF4-FFF2-40B4-BE49-F238E27FC236}">
                  <a16:creationId xmlns:a16="http://schemas.microsoft.com/office/drawing/2014/main" id="{3223F023-5231-49E6-BFE4-CDE9C675EB1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3100" y="3126028"/>
              <a:ext cx="5393817" cy="2888590"/>
            </a:xfrm>
            <a:prstGeom prst="rect">
              <a:avLst/>
            </a:prstGeom>
          </p:spPr>
        </p:pic>
        <p:pic>
          <p:nvPicPr>
            <p:cNvPr id="9" name="Grafik 8">
              <a:extLst>
                <a:ext uri="{FF2B5EF4-FFF2-40B4-BE49-F238E27FC236}">
                  <a16:creationId xmlns:a16="http://schemas.microsoft.com/office/drawing/2014/main" id="{6B414C1E-1AD8-43AC-AEDE-38F5E1321D9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28804" y="3149800"/>
              <a:ext cx="4333342" cy="2939034"/>
            </a:xfrm>
            <a:prstGeom prst="rect">
              <a:avLst/>
            </a:prstGeom>
          </p:spPr>
        </p:pic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271F464B-9ECA-465F-9A4B-11895012442E}"/>
                </a:ext>
              </a:extLst>
            </p:cNvPr>
            <p:cNvSpPr txBox="1"/>
            <p:nvPr/>
          </p:nvSpPr>
          <p:spPr>
            <a:xfrm>
              <a:off x="2140789" y="2503475"/>
              <a:ext cx="275844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dentity</a:t>
              </a:r>
            </a:p>
            <a:p>
              <a:pPr algn="ctr"/>
              <a:r>
                <a:rPr lang="de-DE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ass</a:t>
              </a:r>
              <a:r>
                <a:rPr lang="de-DE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pectrum</a:t>
              </a:r>
              <a:endParaRPr lang="de-DE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2DCCE5E0-382C-4533-9D56-58BBEE881DA5}"/>
                </a:ext>
              </a:extLst>
            </p:cNvPr>
            <p:cNvSpPr txBox="1"/>
            <p:nvPr/>
          </p:nvSpPr>
          <p:spPr>
            <a:xfrm>
              <a:off x="7316255" y="2503475"/>
              <a:ext cx="275844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hemical </a:t>
              </a:r>
              <a:r>
                <a:rPr lang="de-DE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urity</a:t>
              </a:r>
              <a:endParaRPr lang="de-DE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de-DE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HPLC</a:t>
              </a:r>
            </a:p>
          </p:txBody>
        </p:sp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60C65004-B1D0-4BCF-AC88-7CBD2A903B04}"/>
                </a:ext>
              </a:extLst>
            </p:cNvPr>
            <p:cNvSpPr txBox="1"/>
            <p:nvPr/>
          </p:nvSpPr>
          <p:spPr>
            <a:xfrm>
              <a:off x="1434651" y="6121887"/>
              <a:ext cx="417071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Molecular</a:t>
              </a:r>
              <a:r>
                <a:rPr lang="de-DE" sz="1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weight</a:t>
              </a:r>
              <a:r>
                <a:rPr lang="de-DE" sz="16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de-DE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calc</a:t>
              </a:r>
              <a:r>
                <a:rPr lang="de-DE" sz="1600" dirty="0">
                  <a:latin typeface="Arial" panose="020B0604020202020204" pitchFamily="34" charset="0"/>
                  <a:cs typeface="Arial" panose="020B0604020202020204" pitchFamily="34" charset="0"/>
                </a:rPr>
                <a:t>.): 6214.87 g/</a:t>
              </a:r>
              <a:r>
                <a:rPr lang="de-DE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mol</a:t>
              </a:r>
              <a:r>
                <a:rPr lang="de-DE" sz="1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2FF04100-7077-40A8-B7C8-71822E24A6D4}"/>
                </a:ext>
              </a:extLst>
            </p:cNvPr>
            <p:cNvSpPr txBox="1"/>
            <p:nvPr/>
          </p:nvSpPr>
          <p:spPr>
            <a:xfrm>
              <a:off x="4017680" y="213059"/>
              <a:ext cx="417071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NODAGA-KISS1-54</a:t>
              </a:r>
            </a:p>
          </p:txBody>
        </p:sp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BE8C4128-5FAB-4D0D-A1F4-318174C295FD}"/>
                </a:ext>
              </a:extLst>
            </p:cNvPr>
            <p:cNvSpPr txBox="1"/>
            <p:nvPr/>
          </p:nvSpPr>
          <p:spPr>
            <a:xfrm>
              <a:off x="525638" y="815748"/>
              <a:ext cx="282277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-terminal </a:t>
              </a:r>
              <a:r>
                <a:rPr lang="de-DE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odification</a:t>
              </a:r>
              <a:r>
                <a:rPr lang="de-DE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: </a:t>
              </a:r>
              <a:r>
                <a:rPr lang="de-DE" sz="1600" dirty="0">
                  <a:latin typeface="Arial" panose="020B0604020202020204" pitchFamily="34" charset="0"/>
                  <a:cs typeface="Arial" panose="020B0604020202020204" pitchFamily="34" charset="0"/>
                </a:rPr>
                <a:t>NODAGA</a:t>
              </a:r>
            </a:p>
          </p:txBody>
        </p:sp>
        <p:sp>
          <p:nvSpPr>
            <p:cNvPr id="15" name="Textfeld 14">
              <a:extLst>
                <a:ext uri="{FF2B5EF4-FFF2-40B4-BE49-F238E27FC236}">
                  <a16:creationId xmlns:a16="http://schemas.microsoft.com/office/drawing/2014/main" id="{5A61D891-1073-4CAB-A67B-BE80F038A6CF}"/>
                </a:ext>
              </a:extLst>
            </p:cNvPr>
            <p:cNvSpPr txBox="1"/>
            <p:nvPr/>
          </p:nvSpPr>
          <p:spPr>
            <a:xfrm>
              <a:off x="3059424" y="815748"/>
              <a:ext cx="9084333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eptide </a:t>
              </a:r>
              <a:r>
                <a:rPr lang="de-DE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equence</a:t>
              </a:r>
              <a:r>
                <a:rPr lang="de-DE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: </a:t>
              </a:r>
              <a:r>
                <a:rPr lang="de-DE" sz="1600" dirty="0">
                  <a:latin typeface="Arial" panose="020B0604020202020204" pitchFamily="34" charset="0"/>
                  <a:cs typeface="Arial" panose="020B0604020202020204" pitchFamily="34" charset="0"/>
                </a:rPr>
                <a:t/>
              </a:r>
              <a:br>
                <a:rPr lang="de-DE" sz="1600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de-DE" sz="1600" dirty="0">
                  <a:latin typeface="Arial" panose="020B0604020202020204" pitchFamily="34" charset="0"/>
                  <a:cs typeface="Arial" panose="020B0604020202020204" pitchFamily="34" charset="0"/>
                </a:rPr>
                <a:t>GTSLSPPPESSGSRQQPGLSAPHSRQIPAP</a:t>
              </a:r>
            </a:p>
            <a:p>
              <a:pPr algn="ctr"/>
              <a:r>
                <a:rPr lang="de-DE" sz="1600" dirty="0">
                  <a:latin typeface="Arial" panose="020B0604020202020204" pitchFamily="34" charset="0"/>
                  <a:cs typeface="Arial" panose="020B0604020202020204" pitchFamily="34" charset="0"/>
                </a:rPr>
                <a:t>QGAVLVQREKDLPNYNWNSFGLRF-NH</a:t>
              </a:r>
              <a:r>
                <a:rPr lang="de-DE" sz="16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59135170-1F2F-46D8-86F7-19E40DC321A9}"/>
                </a:ext>
              </a:extLst>
            </p:cNvPr>
            <p:cNvSpPr txBox="1"/>
            <p:nvPr/>
          </p:nvSpPr>
          <p:spPr>
            <a:xfrm>
              <a:off x="6652009" y="6122988"/>
              <a:ext cx="417071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Purity</a:t>
              </a:r>
              <a:r>
                <a:rPr lang="de-DE" sz="1600">
                  <a:latin typeface="Arial" panose="020B0604020202020204" pitchFamily="34" charset="0"/>
                  <a:cs typeface="Arial" panose="020B0604020202020204" pitchFamily="34" charset="0"/>
                </a:rPr>
                <a:t>: &gt; 99 % 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7" name="Objekt 16">
              <a:extLst>
                <a:ext uri="{FF2B5EF4-FFF2-40B4-BE49-F238E27FC236}">
                  <a16:creationId xmlns:a16="http://schemas.microsoft.com/office/drawing/2014/main" id="{95F9E511-97F4-42DF-9292-547DCBAAE4D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7515778"/>
                </p:ext>
              </p:extLst>
            </p:nvPr>
          </p:nvGraphicFramePr>
          <p:xfrm>
            <a:off x="795613" y="1439947"/>
            <a:ext cx="1606752" cy="12867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1" name="ISIS/Draw Sketch" r:id="rId5" imgW="2295360" imgH="1838160" progId="ISISServer">
                    <p:embed/>
                  </p:oleObj>
                </mc:Choice>
                <mc:Fallback>
                  <p:oleObj name="ISIS/Draw Sketch" r:id="rId5" imgW="2295360" imgH="1838160" progId="ISISServer">
                    <p:embed/>
                    <p:pic>
                      <p:nvPicPr>
                        <p:cNvPr id="4" name="Objekt 3">
                          <a:extLst>
                            <a:ext uri="{FF2B5EF4-FFF2-40B4-BE49-F238E27FC236}">
                              <a16:creationId xmlns:a16="http://schemas.microsoft.com/office/drawing/2014/main" id="{DCFC4F36-01B2-4F05-86FA-B92AF3D9813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795613" y="1439947"/>
                          <a:ext cx="1606752" cy="12867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7160393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</Words>
  <Application>Microsoft Office PowerPoint</Application>
  <PresentationFormat>Breitbild</PresentationFormat>
  <Paragraphs>10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ISIS/Draw Sketch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Ina</dc:creator>
  <cp:lastModifiedBy>Israel, Ina</cp:lastModifiedBy>
  <cp:revision>12</cp:revision>
  <dcterms:created xsi:type="dcterms:W3CDTF">2023-12-10T14:24:44Z</dcterms:created>
  <dcterms:modified xsi:type="dcterms:W3CDTF">2023-12-11T14:59:11Z</dcterms:modified>
</cp:coreProperties>
</file>